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74" r:id="rId3"/>
    <p:sldId id="275" r:id="rId4"/>
    <p:sldId id="276" r:id="rId5"/>
    <p:sldId id="296" r:id="rId6"/>
    <p:sldId id="297" r:id="rId7"/>
    <p:sldId id="27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14"/>
  </p:normalViewPr>
  <p:slideViewPr>
    <p:cSldViewPr snapToGrid="0" snapToObjects="1">
      <p:cViewPr varScale="1">
        <p:scale>
          <a:sx n="112" d="100"/>
          <a:sy n="112" d="100"/>
        </p:scale>
        <p:origin x="5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4E94DF-0B61-214A-A645-1CCF6A02EF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B6EDF1-173A-9240-87E5-726CCF437D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761A3D-BBCC-804E-91DE-96AD84AF6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07491-F5F1-3143-92C4-384E152EA1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0767CB-87CE-D14D-A647-0501A8DFE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763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3C558-DAF8-C241-A2D7-A106A68C6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39467B-520C-544A-AABD-FA461BC1EE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7DAAAD-F7EB-044B-AC31-1B9AA80164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EEAB6-C53C-F446-BF34-E91FD3506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6C9237-96BC-8D4E-836A-96034C169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768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3899778-5BC5-EE45-BE63-1EA35388E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44DD94-7F12-A840-B8E9-BAB02657A1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08FF3C-7FE3-5740-BD00-C0020CC0F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5F32C-AA1A-0049-96E4-CE3CA3194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0AF218-AD88-6F47-BBF8-8C0296A27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669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37729-59FB-5346-962C-12F7ED3B6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85DA47-98AD-B54F-A0BC-E23FDA2AB2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66B79-F6D2-9A41-9788-45111FFF1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E54DE4-B167-8A4A-A5FA-5EB1545B0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0188DC-4E91-7746-8BFB-9CE31A9632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457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9BFA4-8868-7E41-9C60-DE0FD155C2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D10D9A-0C8B-FB46-A2D7-90EB5DF839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DCC749-84E2-A745-9AB6-84AD002F1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764B70-2B2B-CF49-8403-10059EC1F5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1C476-1BD4-F14E-9D98-582366B5B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1888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097796-D4FD-6843-8EB6-C5A04EC60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01E4E6-1ACF-D648-8877-BA30381CA3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231E7D-0AD7-B749-9C78-AE579FEE98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E278FD-80D0-6943-A005-D5695BBEF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4D8E30-6CE4-1E40-918A-6DF2B733B8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AECF00-776E-464A-8BA7-5DFBE7C29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3495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D3996B-5BFC-6B42-98C0-C31C3C31DD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7A2BE-90A7-2444-9862-1744B25F2B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3E74EA-1DFA-7340-A12A-5BDB332A30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60521E-467F-1A49-840D-65E2A1228F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C3081E9-4B59-8D4F-AAE9-A84707EE3F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5BF470-02B3-4F45-9B97-C283431F1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C1CDC7-6E01-AE43-AD48-1DFF065BE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F0DD0B-042F-1D47-8EE4-62CEDC395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816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4D02B-C6AF-594F-84B1-72EACC1CF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C4B829-6A63-A449-8C83-D2A015006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2B65965-DB6A-BB47-843F-2C1B78CAF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06FD95-3C08-B54F-A944-481CCE8D2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75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108B73-8318-C349-8D3F-4B6F7DB3E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44D2BE8-C2AA-7D42-BC45-032914F07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0DE2AA3-F042-2941-81EC-18F172474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63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66773E-6527-EC49-84B1-1EE9810379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4A776D-F7E3-8C40-8E56-BAEB345998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E09D4B-F0F6-2C46-B412-1B86BFE4BE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3AEAA4-8A7F-7B49-BB58-19FDCA8D0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1490ED-0CB5-9241-AD7A-286D74AAD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AD6E8F-FD74-E041-98B7-EAEBC1EC6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184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4BE44D-2B52-D146-88DE-BCE235941E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DFE7FF-DE3D-CF4D-A19A-D99E4933F36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0C0B98-238F-064A-95FD-E66A03EF43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B8DB05-A45B-624E-AFC3-37FE3E12F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8385CE-A9AB-5B40-9842-9F3CC808F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C913C1-228C-B544-B670-FB569CCC6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248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F62D51-4F20-7F41-B1B5-D4D8F352CD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3E3D30-3D12-504C-BA14-8FC5A748C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E86CF9-F113-C349-B370-7B1D943538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E8F66-AFE4-E345-8D9E-B52CBB5230F8}" type="datetimeFigureOut">
              <a:rPr lang="en-US" smtClean="0"/>
              <a:t>2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3528B0-0C81-2E45-A0ED-35BD619BE9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43231-2642-104F-9DC1-CDD1FA87EF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F157FF-BD18-CC41-A437-597C140D45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26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4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3.png"/><Relationship Id="rId5" Type="http://schemas.openxmlformats.org/officeDocument/2006/relationships/slideLayout" Target="../slideLayouts/slideLayout6.xml"/><Relationship Id="rId4" Type="http://schemas.openxmlformats.org/officeDocument/2006/relationships/video" Target="../media/media2.mp4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2235200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Resuscitation Leadership Training  </a:t>
            </a:r>
            <a:br>
              <a:rPr lang="en-US" dirty="0"/>
            </a:br>
            <a:br>
              <a:rPr lang="en-US" dirty="0"/>
            </a:br>
            <a:r>
              <a:rPr lang="en-US" sz="4400" dirty="0"/>
              <a:t>Simulation Case: Massive Pulmonary Embolism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5202238"/>
            <a:ext cx="9144000" cy="1655762"/>
          </a:xfrm>
        </p:spPr>
        <p:txBody>
          <a:bodyPr/>
          <a:lstStyle/>
          <a:p>
            <a:r>
              <a:rPr lang="en-US" dirty="0"/>
              <a:t>All Material Author Owne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664416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KG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3" t="3924" r="3492" b="4110"/>
          <a:stretch/>
        </p:blipFill>
        <p:spPr>
          <a:xfrm>
            <a:off x="1981200" y="1585914"/>
            <a:ext cx="7620001" cy="3943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7794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XR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1391" y="1242227"/>
            <a:ext cx="5201382" cy="5201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75678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- Echo</a:t>
            </a:r>
          </a:p>
        </p:txBody>
      </p:sp>
      <p:pic>
        <p:nvPicPr>
          <p:cNvPr id="4" name="dilated apical 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621920" y="3008524"/>
            <a:ext cx="5042981" cy="3782236"/>
          </a:xfrm>
          <a:prstGeom prst="rect">
            <a:avLst/>
          </a:prstGeom>
        </p:spPr>
      </p:pic>
      <p:pic>
        <p:nvPicPr>
          <p:cNvPr id="5" name="D sign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651842" y="274639"/>
            <a:ext cx="5016159" cy="37621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58509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66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10166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1008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0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1" fill="hold">
                      <p:stCondLst>
                        <p:cond delay="0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5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21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Normal IVC">
            <a:hlinkClick r:id="" action="ppaction://media"/>
            <a:extLst>
              <a:ext uri="{FF2B5EF4-FFF2-40B4-BE49-F238E27FC236}">
                <a16:creationId xmlns:a16="http://schemas.microsoft.com/office/drawing/2014/main" id="{DED1E85E-19DC-DC4C-A34F-4A72430040F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829917" y="1417638"/>
            <a:ext cx="6218656" cy="4663992"/>
          </a:xfrm>
          <a:prstGeom prst="rect">
            <a:avLst/>
          </a:prstGeom>
        </p:spPr>
      </p:pic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CUS - IVC</a:t>
            </a:r>
          </a:p>
        </p:txBody>
      </p:sp>
    </p:spTree>
    <p:extLst>
      <p:ext uri="{BB962C8B-B14F-4D97-AF65-F5344CB8AC3E}">
        <p14:creationId xmlns:p14="http://schemas.microsoft.com/office/powerpoint/2010/main" val="293954447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2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08E511B-F929-3242-BA23-60BE6C3CB3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0459" y="1529987"/>
            <a:ext cx="6961482" cy="4699000"/>
          </a:xfrm>
          <a:prstGeom prst="rect">
            <a:avLst/>
          </a:prstGeom>
        </p:spPr>
      </p:pic>
      <p:sp>
        <p:nvSpPr>
          <p:cNvPr id="3" name="Title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POCUS </a:t>
            </a:r>
            <a:r>
              <a:rPr lang="en-US" dirty="0"/>
              <a:t>- Lung</a:t>
            </a:r>
          </a:p>
        </p:txBody>
      </p:sp>
    </p:spTree>
    <p:extLst>
      <p:ext uri="{BB962C8B-B14F-4D97-AF65-F5344CB8AC3E}">
        <p14:creationId xmlns:p14="http://schemas.microsoft.com/office/powerpoint/2010/main" val="14931435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VBG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70415" y="1417639"/>
            <a:ext cx="6041571" cy="50783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ood gas values</a:t>
            </a:r>
          </a:p>
          <a:p>
            <a:r>
              <a:rPr lang="en-US" b="1" i="1" dirty="0"/>
              <a:t>	pH			7.25</a:t>
            </a:r>
            <a:endParaRPr lang="en-US" dirty="0"/>
          </a:p>
          <a:p>
            <a:r>
              <a:rPr lang="en-US" b="1" i="1" dirty="0"/>
              <a:t>	pCO2			31	mmHg</a:t>
            </a:r>
            <a:endParaRPr lang="en-US" dirty="0"/>
          </a:p>
          <a:p>
            <a:r>
              <a:rPr lang="en-US" dirty="0"/>
              <a:t>	pO2			12	mmHg</a:t>
            </a:r>
          </a:p>
          <a:p>
            <a:r>
              <a:rPr lang="en-US" dirty="0"/>
              <a:t>Oximetry values</a:t>
            </a:r>
          </a:p>
          <a:p>
            <a:r>
              <a:rPr lang="en-US" dirty="0"/>
              <a:t>	</a:t>
            </a:r>
            <a:r>
              <a:rPr lang="en-US" b="1" i="1" dirty="0" err="1"/>
              <a:t>ctHb</a:t>
            </a:r>
            <a:r>
              <a:rPr lang="en-US" b="1" i="1" dirty="0"/>
              <a:t>			12	g/</a:t>
            </a:r>
            <a:r>
              <a:rPr lang="en-US" b="1" i="1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dirty="0" err="1"/>
              <a:t>Hctc</a:t>
            </a:r>
            <a:r>
              <a:rPr lang="en-US" dirty="0"/>
              <a:t>			36	%</a:t>
            </a:r>
          </a:p>
          <a:p>
            <a:r>
              <a:rPr lang="en-US" dirty="0"/>
              <a:t>	sO2			17.6	%</a:t>
            </a:r>
          </a:p>
          <a:p>
            <a:r>
              <a:rPr lang="en-US" dirty="0"/>
              <a:t>	</a:t>
            </a:r>
            <a:r>
              <a:rPr lang="en-US" dirty="0" err="1"/>
              <a:t>FMetHb</a:t>
            </a:r>
            <a:r>
              <a:rPr lang="en-US" dirty="0"/>
              <a:t>		0.1	%</a:t>
            </a:r>
          </a:p>
          <a:p>
            <a:r>
              <a:rPr lang="en-US" dirty="0"/>
              <a:t>Electrolyte values</a:t>
            </a:r>
          </a:p>
          <a:p>
            <a:r>
              <a:rPr lang="en-US" dirty="0"/>
              <a:t>	Na			139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l			98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	Ca			1.06	</a:t>
            </a:r>
            <a:r>
              <a:rPr lang="en-US" dirty="0" err="1"/>
              <a:t>mmol</a:t>
            </a:r>
            <a:r>
              <a:rPr lang="en-US" dirty="0"/>
              <a:t>/L</a:t>
            </a:r>
          </a:p>
          <a:p>
            <a:r>
              <a:rPr lang="en-US" dirty="0"/>
              <a:t>Metabolite values</a:t>
            </a:r>
          </a:p>
          <a:p>
            <a:r>
              <a:rPr lang="en-US" dirty="0"/>
              <a:t>	</a:t>
            </a:r>
            <a:r>
              <a:rPr lang="en-US" dirty="0" err="1"/>
              <a:t>Gluc</a:t>
            </a:r>
            <a:r>
              <a:rPr lang="en-US" dirty="0"/>
              <a:t>			147	mg/</a:t>
            </a:r>
            <a:r>
              <a:rPr lang="en-US" dirty="0" err="1"/>
              <a:t>dL</a:t>
            </a:r>
            <a:endParaRPr lang="en-US" dirty="0"/>
          </a:p>
          <a:p>
            <a:r>
              <a:rPr lang="en-US" dirty="0"/>
              <a:t>	</a:t>
            </a:r>
            <a:r>
              <a:rPr lang="en-US" b="1" i="1" dirty="0"/>
              <a:t>Lac			3.5	</a:t>
            </a:r>
            <a:r>
              <a:rPr lang="en-US" b="1" i="1" dirty="0" err="1"/>
              <a:t>mmol</a:t>
            </a:r>
            <a:r>
              <a:rPr lang="en-US" b="1" i="1" dirty="0"/>
              <a:t>/L</a:t>
            </a:r>
            <a:endParaRPr lang="en-US" dirty="0"/>
          </a:p>
          <a:p>
            <a:r>
              <a:rPr lang="en-US" dirty="0"/>
              <a:t>Acid-base status</a:t>
            </a:r>
          </a:p>
          <a:p>
            <a:r>
              <a:rPr lang="en-US" dirty="0"/>
              <a:t>	</a:t>
            </a:r>
            <a:r>
              <a:rPr lang="en-US" b="1" i="1" dirty="0"/>
              <a:t>cHCO3			19	</a:t>
            </a:r>
            <a:r>
              <a:rPr lang="en-US" b="1" i="1" dirty="0" err="1"/>
              <a:t>mmol</a:t>
            </a:r>
            <a:r>
              <a:rPr lang="en-US" b="1" i="1" dirty="0"/>
              <a:t>/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6417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53</Words>
  <Application>Microsoft Macintosh PowerPoint</Application>
  <PresentationFormat>Widescreen</PresentationFormat>
  <Paragraphs>26</Paragraphs>
  <Slides>7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Resuscitation Leadership Training    Simulation Case: Massive Pulmonary Embolism</vt:lpstr>
      <vt:lpstr>EKG</vt:lpstr>
      <vt:lpstr>CXR</vt:lpstr>
      <vt:lpstr>POCUS - Echo</vt:lpstr>
      <vt:lpstr>POCUS - IVC</vt:lpstr>
      <vt:lpstr>POCUS - Lung</vt:lpstr>
      <vt:lpstr>VBG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uscitation Leadership Training    Simulation Case: Massive Pulmonary Embolism</dc:title>
  <dc:creator>Microsoft Office User</dc:creator>
  <cp:lastModifiedBy>Microsoft Office User</cp:lastModifiedBy>
  <cp:revision>3</cp:revision>
  <dcterms:created xsi:type="dcterms:W3CDTF">2022-02-26T18:24:41Z</dcterms:created>
  <dcterms:modified xsi:type="dcterms:W3CDTF">2022-02-26T19:13:28Z</dcterms:modified>
</cp:coreProperties>
</file>